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52" r:id="rId1"/>
  </p:sldMasterIdLst>
  <p:sldIdLst>
    <p:sldId id="258" r:id="rId2"/>
  </p:sldIdLst>
  <p:sldSz cx="6858000" cy="9001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91" autoAdjust="0"/>
  </p:normalViewPr>
  <p:slideViewPr>
    <p:cSldViewPr snapToGrid="0">
      <p:cViewPr varScale="1">
        <p:scale>
          <a:sx n="89" d="100"/>
          <a:sy n="89" d="100"/>
        </p:scale>
        <p:origin x="288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73101"/>
            <a:ext cx="5829300" cy="313372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727675"/>
            <a:ext cx="5143500" cy="2173188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033934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7947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79227"/>
            <a:ext cx="1478756" cy="762803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79227"/>
            <a:ext cx="4350544" cy="762803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4061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48697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44033"/>
            <a:ext cx="5915025" cy="374421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023672"/>
            <a:ext cx="5915025" cy="1968995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4498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396133"/>
            <a:ext cx="2914650" cy="571113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396133"/>
            <a:ext cx="2914650" cy="5711131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3265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79229"/>
            <a:ext cx="5915025" cy="173980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06526"/>
            <a:ext cx="2901255" cy="108138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287911"/>
            <a:ext cx="2901255" cy="483602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06526"/>
            <a:ext cx="2915543" cy="108138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287911"/>
            <a:ext cx="2915543" cy="483602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64193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7631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65224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075"/>
            <a:ext cx="2211884" cy="210026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295997"/>
            <a:ext cx="3471863" cy="639663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0338"/>
            <a:ext cx="2211884" cy="500270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8862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0075"/>
            <a:ext cx="2211884" cy="210026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295997"/>
            <a:ext cx="3471863" cy="6396633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00338"/>
            <a:ext cx="2211884" cy="500270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8503112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79229"/>
            <a:ext cx="5915025" cy="173980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396133"/>
            <a:ext cx="5915025" cy="57111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342711"/>
            <a:ext cx="154305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342711"/>
            <a:ext cx="2314575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342711"/>
            <a:ext cx="1543050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35794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53" r:id="rId1"/>
    <p:sldLayoutId id="2147483854" r:id="rId2"/>
    <p:sldLayoutId id="2147483855" r:id="rId3"/>
    <p:sldLayoutId id="2147483856" r:id="rId4"/>
    <p:sldLayoutId id="2147483857" r:id="rId5"/>
    <p:sldLayoutId id="2147483858" r:id="rId6"/>
    <p:sldLayoutId id="2147483859" r:id="rId7"/>
    <p:sldLayoutId id="2147483860" r:id="rId8"/>
    <p:sldLayoutId id="2147483861" r:id="rId9"/>
    <p:sldLayoutId id="2147483862" r:id="rId10"/>
    <p:sldLayoutId id="214748386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2" Type="http://schemas.openxmlformats.org/officeDocument/2006/relationships/image" Target="../media/image1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/>
          <p:cNvGrpSpPr/>
          <p:nvPr/>
        </p:nvGrpSpPr>
        <p:grpSpPr>
          <a:xfrm>
            <a:off x="-21004" y="656391"/>
            <a:ext cx="6934962" cy="7835024"/>
            <a:chOff x="-21004" y="656391"/>
            <a:chExt cx="6934962" cy="7835024"/>
          </a:xfrm>
        </p:grpSpPr>
        <p:pic>
          <p:nvPicPr>
            <p:cNvPr id="283" name="图片 282"/>
            <p:cNvPicPr>
              <a:picLocks noChangeAspect="1"/>
            </p:cNvPicPr>
            <p:nvPr/>
          </p:nvPicPr>
          <p:blipFill rotWithShape="1">
            <a:blip r:embed="rId2"/>
            <a:srcRect l="827" t="3439" r="1137" b="18796"/>
            <a:stretch/>
          </p:blipFill>
          <p:spPr>
            <a:xfrm>
              <a:off x="270669" y="1180362"/>
              <a:ext cx="6485020" cy="7251183"/>
            </a:xfrm>
            <a:prstGeom prst="rect">
              <a:avLst/>
            </a:prstGeom>
          </p:spPr>
        </p:pic>
        <p:sp>
          <p:nvSpPr>
            <p:cNvPr id="284" name="弧形 283"/>
            <p:cNvSpPr/>
            <p:nvPr/>
          </p:nvSpPr>
          <p:spPr>
            <a:xfrm rot="20567673">
              <a:off x="424856" y="863316"/>
              <a:ext cx="6072360" cy="4421429"/>
            </a:xfrm>
            <a:prstGeom prst="arc">
              <a:avLst>
                <a:gd name="adj1" fmla="val 10250745"/>
                <a:gd name="adj2" fmla="val 1294470"/>
              </a:avLst>
            </a:prstGeom>
            <a:ln w="19050"/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0" name="弧形 289"/>
            <p:cNvSpPr/>
            <p:nvPr/>
          </p:nvSpPr>
          <p:spPr>
            <a:xfrm rot="9847838">
              <a:off x="-16427" y="2409168"/>
              <a:ext cx="6888691" cy="5866089"/>
            </a:xfrm>
            <a:prstGeom prst="arc">
              <a:avLst>
                <a:gd name="adj1" fmla="val 9901839"/>
                <a:gd name="adj2" fmla="val 1569346"/>
              </a:avLst>
            </a:prstGeom>
            <a:ln w="1905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1" name="矩形 290"/>
            <p:cNvSpPr/>
            <p:nvPr/>
          </p:nvSpPr>
          <p:spPr>
            <a:xfrm rot="20672106">
              <a:off x="2450213" y="8122083"/>
              <a:ext cx="355738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-</a:t>
              </a:r>
              <a:r>
                <a:rPr lang="en-US" altLang="zh-CN" dirty="0" err="1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ulonolactone</a:t>
              </a:r>
              <a:r>
                <a:rPr lang="en-US" altLang="zh-CN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oxidase (GULO)</a:t>
              </a:r>
              <a:endParaRPr lang="zh-CN" altLang="en-US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2" name="矩形 291"/>
            <p:cNvSpPr/>
            <p:nvPr/>
          </p:nvSpPr>
          <p:spPr>
            <a:xfrm rot="20564077">
              <a:off x="-21004" y="656391"/>
              <a:ext cx="517007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dirty="0">
                  <a:solidFill>
                    <a:srgbClr val="007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-galactono-1,4-lactone dehydrogenase (GLDH)</a:t>
              </a:r>
              <a:endParaRPr lang="zh-CN" altLang="en-US" dirty="0">
                <a:solidFill>
                  <a:srgbClr val="0070C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矩形 292"/>
            <p:cNvSpPr/>
            <p:nvPr/>
          </p:nvSpPr>
          <p:spPr>
            <a:xfrm rot="1053414">
              <a:off x="4444149" y="1149128"/>
              <a:ext cx="1097925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lga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4" name="矩形 293"/>
            <p:cNvSpPr/>
            <p:nvPr/>
          </p:nvSpPr>
          <p:spPr>
            <a:xfrm rot="17932783">
              <a:off x="306228" y="2478275"/>
              <a:ext cx="1536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Higher plants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矩形 294"/>
            <p:cNvSpPr/>
            <p:nvPr/>
          </p:nvSpPr>
          <p:spPr>
            <a:xfrm rot="1053414">
              <a:off x="720942" y="6972365"/>
              <a:ext cx="1097925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Algae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矩形 295"/>
            <p:cNvSpPr/>
            <p:nvPr/>
          </p:nvSpPr>
          <p:spPr>
            <a:xfrm rot="20636555">
              <a:off x="3645811" y="7717698"/>
              <a:ext cx="1536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Higher plants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任意多边形 5"/>
            <p:cNvSpPr/>
            <p:nvPr/>
          </p:nvSpPr>
          <p:spPr>
            <a:xfrm>
              <a:off x="191028" y="1178988"/>
              <a:ext cx="6542262" cy="7067779"/>
            </a:xfrm>
            <a:custGeom>
              <a:avLst/>
              <a:gdLst>
                <a:gd name="connsiteX0" fmla="*/ 113772 w 6542262"/>
                <a:gd name="connsiteY0" fmla="*/ 3621612 h 7067779"/>
                <a:gd name="connsiteX1" fmla="*/ 18522 w 6542262"/>
                <a:gd name="connsiteY1" fmla="*/ 5021787 h 7067779"/>
                <a:gd name="connsiteX2" fmla="*/ 104247 w 6542262"/>
                <a:gd name="connsiteY2" fmla="*/ 5517087 h 7067779"/>
                <a:gd name="connsiteX3" fmla="*/ 647172 w 6542262"/>
                <a:gd name="connsiteY3" fmla="*/ 5783787 h 7067779"/>
                <a:gd name="connsiteX4" fmla="*/ 751947 w 6542262"/>
                <a:gd name="connsiteY4" fmla="*/ 5774262 h 7067779"/>
                <a:gd name="connsiteX5" fmla="*/ 1228197 w 6542262"/>
                <a:gd name="connsiteY5" fmla="*/ 5898087 h 7067779"/>
                <a:gd name="connsiteX6" fmla="*/ 1704447 w 6542262"/>
                <a:gd name="connsiteY6" fmla="*/ 6164787 h 7067779"/>
                <a:gd name="connsiteX7" fmla="*/ 2190222 w 6542262"/>
                <a:gd name="connsiteY7" fmla="*/ 6393387 h 7067779"/>
                <a:gd name="connsiteX8" fmla="*/ 2475972 w 6542262"/>
                <a:gd name="connsiteY8" fmla="*/ 6498162 h 7067779"/>
                <a:gd name="connsiteX9" fmla="*/ 2552172 w 6542262"/>
                <a:gd name="connsiteY9" fmla="*/ 6964887 h 7067779"/>
                <a:gd name="connsiteX10" fmla="*/ 2799822 w 6542262"/>
                <a:gd name="connsiteY10" fmla="*/ 7050612 h 7067779"/>
                <a:gd name="connsiteX11" fmla="*/ 3190347 w 6542262"/>
                <a:gd name="connsiteY11" fmla="*/ 6717237 h 7067779"/>
                <a:gd name="connsiteX12" fmla="*/ 3514197 w 6542262"/>
                <a:gd name="connsiteY12" fmla="*/ 6707712 h 7067779"/>
                <a:gd name="connsiteX13" fmla="*/ 4361922 w 6542262"/>
                <a:gd name="connsiteY13" fmla="*/ 6631512 h 7067779"/>
                <a:gd name="connsiteX14" fmla="*/ 5019147 w 6542262"/>
                <a:gd name="connsiteY14" fmla="*/ 6326712 h 7067779"/>
                <a:gd name="connsiteX15" fmla="*/ 5695422 w 6542262"/>
                <a:gd name="connsiteY15" fmla="*/ 5583762 h 7067779"/>
                <a:gd name="connsiteX16" fmla="*/ 5600172 w 6542262"/>
                <a:gd name="connsiteY16" fmla="*/ 5364687 h 7067779"/>
                <a:gd name="connsiteX17" fmla="*/ 6085947 w 6542262"/>
                <a:gd name="connsiteY17" fmla="*/ 5174187 h 7067779"/>
                <a:gd name="connsiteX18" fmla="*/ 6143097 w 6542262"/>
                <a:gd name="connsiteY18" fmla="*/ 4840812 h 7067779"/>
                <a:gd name="connsiteX19" fmla="*/ 6200247 w 6542262"/>
                <a:gd name="connsiteY19" fmla="*/ 4412187 h 7067779"/>
                <a:gd name="connsiteX20" fmla="*/ 6447897 w 6542262"/>
                <a:gd name="connsiteY20" fmla="*/ 4374087 h 7067779"/>
                <a:gd name="connsiteX21" fmla="*/ 6533622 w 6542262"/>
                <a:gd name="connsiteY21" fmla="*/ 4183587 h 7067779"/>
                <a:gd name="connsiteX22" fmla="*/ 6257397 w 6542262"/>
                <a:gd name="connsiteY22" fmla="*/ 3802587 h 7067779"/>
                <a:gd name="connsiteX23" fmla="*/ 6228822 w 6542262"/>
                <a:gd name="connsiteY23" fmla="*/ 3307287 h 7067779"/>
                <a:gd name="connsiteX24" fmla="*/ 6171672 w 6542262"/>
                <a:gd name="connsiteY24" fmla="*/ 2583387 h 7067779"/>
                <a:gd name="connsiteX25" fmla="*/ 5885922 w 6542262"/>
                <a:gd name="connsiteY25" fmla="*/ 1678512 h 7067779"/>
                <a:gd name="connsiteX26" fmla="*/ 5657322 w 6542262"/>
                <a:gd name="connsiteY26" fmla="*/ 773637 h 7067779"/>
                <a:gd name="connsiteX27" fmla="*/ 5266797 w 6542262"/>
                <a:gd name="connsiteY27" fmla="*/ 383112 h 7067779"/>
                <a:gd name="connsiteX28" fmla="*/ 4723872 w 6542262"/>
                <a:gd name="connsiteY28" fmla="*/ 449787 h 7067779"/>
                <a:gd name="connsiteX29" fmla="*/ 4285722 w 6542262"/>
                <a:gd name="connsiteY29" fmla="*/ 78312 h 7067779"/>
                <a:gd name="connsiteX30" fmla="*/ 3523722 w 6542262"/>
                <a:gd name="connsiteY30" fmla="*/ 97362 h 7067779"/>
                <a:gd name="connsiteX31" fmla="*/ 2990322 w 6542262"/>
                <a:gd name="connsiteY31" fmla="*/ 68787 h 7067779"/>
                <a:gd name="connsiteX32" fmla="*/ 2599797 w 6542262"/>
                <a:gd name="connsiteY32" fmla="*/ 21162 h 7067779"/>
                <a:gd name="connsiteX33" fmla="*/ 1980672 w 6542262"/>
                <a:gd name="connsiteY33" fmla="*/ 449787 h 7067779"/>
                <a:gd name="connsiteX34" fmla="*/ 1552047 w 6542262"/>
                <a:gd name="connsiteY34" fmla="*/ 706962 h 7067779"/>
                <a:gd name="connsiteX35" fmla="*/ 1294872 w 6542262"/>
                <a:gd name="connsiteY35" fmla="*/ 1049862 h 7067779"/>
                <a:gd name="connsiteX36" fmla="*/ 1161522 w 6542262"/>
                <a:gd name="connsiteY36" fmla="*/ 1354662 h 7067779"/>
                <a:gd name="connsiteX37" fmla="*/ 856722 w 6542262"/>
                <a:gd name="connsiteY37" fmla="*/ 2002362 h 7067779"/>
                <a:gd name="connsiteX38" fmla="*/ 790047 w 6542262"/>
                <a:gd name="connsiteY38" fmla="*/ 2659587 h 7067779"/>
                <a:gd name="connsiteX39" fmla="*/ 761472 w 6542262"/>
                <a:gd name="connsiteY39" fmla="*/ 3154887 h 7067779"/>
                <a:gd name="connsiteX40" fmla="*/ 1228197 w 6542262"/>
                <a:gd name="connsiteY40" fmla="*/ 3135837 h 7067779"/>
                <a:gd name="connsiteX41" fmla="*/ 2361672 w 6542262"/>
                <a:gd name="connsiteY41" fmla="*/ 2754837 h 7067779"/>
                <a:gd name="connsiteX42" fmla="*/ 2399772 w 6542262"/>
                <a:gd name="connsiteY42" fmla="*/ 2745312 h 7067779"/>
                <a:gd name="connsiteX43" fmla="*/ 2371197 w 6542262"/>
                <a:gd name="connsiteY43" fmla="*/ 2621487 h 7067779"/>
                <a:gd name="connsiteX44" fmla="*/ 2390247 w 6542262"/>
                <a:gd name="connsiteY44" fmla="*/ 2440512 h 7067779"/>
                <a:gd name="connsiteX45" fmla="*/ 2447397 w 6542262"/>
                <a:gd name="connsiteY45" fmla="*/ 2326212 h 7067779"/>
                <a:gd name="connsiteX46" fmla="*/ 2561697 w 6542262"/>
                <a:gd name="connsiteY46" fmla="*/ 2173812 h 7067779"/>
                <a:gd name="connsiteX47" fmla="*/ 2866497 w 6542262"/>
                <a:gd name="connsiteY47" fmla="*/ 2097612 h 7067779"/>
                <a:gd name="connsiteX48" fmla="*/ 3076047 w 6542262"/>
                <a:gd name="connsiteY48" fmla="*/ 2049987 h 7067779"/>
                <a:gd name="connsiteX49" fmla="*/ 3257022 w 6542262"/>
                <a:gd name="connsiteY49" fmla="*/ 2021412 h 7067779"/>
                <a:gd name="connsiteX50" fmla="*/ 3323697 w 6542262"/>
                <a:gd name="connsiteY50" fmla="*/ 1935687 h 7067779"/>
                <a:gd name="connsiteX51" fmla="*/ 3437997 w 6542262"/>
                <a:gd name="connsiteY51" fmla="*/ 2030937 h 7067779"/>
                <a:gd name="connsiteX52" fmla="*/ 3590397 w 6542262"/>
                <a:gd name="connsiteY52" fmla="*/ 1992837 h 7067779"/>
                <a:gd name="connsiteX53" fmla="*/ 3657072 w 6542262"/>
                <a:gd name="connsiteY53" fmla="*/ 1859487 h 7067779"/>
                <a:gd name="connsiteX54" fmla="*/ 3866622 w 6542262"/>
                <a:gd name="connsiteY54" fmla="*/ 1954737 h 7067779"/>
                <a:gd name="connsiteX55" fmla="*/ 4114272 w 6542262"/>
                <a:gd name="connsiteY55" fmla="*/ 2002362 h 7067779"/>
                <a:gd name="connsiteX56" fmla="*/ 4228572 w 6542262"/>
                <a:gd name="connsiteY56" fmla="*/ 2126187 h 7067779"/>
                <a:gd name="connsiteX57" fmla="*/ 4428597 w 6542262"/>
                <a:gd name="connsiteY57" fmla="*/ 2316687 h 7067779"/>
                <a:gd name="connsiteX58" fmla="*/ 4476222 w 6542262"/>
                <a:gd name="connsiteY58" fmla="*/ 2573862 h 7067779"/>
                <a:gd name="connsiteX59" fmla="*/ 4600047 w 6542262"/>
                <a:gd name="connsiteY59" fmla="*/ 2831037 h 7067779"/>
                <a:gd name="connsiteX60" fmla="*/ 4809597 w 6542262"/>
                <a:gd name="connsiteY60" fmla="*/ 3288237 h 7067779"/>
                <a:gd name="connsiteX61" fmla="*/ 4885797 w 6542262"/>
                <a:gd name="connsiteY61" fmla="*/ 3402537 h 7067779"/>
                <a:gd name="connsiteX62" fmla="*/ 4895322 w 6542262"/>
                <a:gd name="connsiteY62" fmla="*/ 3535887 h 7067779"/>
                <a:gd name="connsiteX63" fmla="*/ 4914372 w 6542262"/>
                <a:gd name="connsiteY63" fmla="*/ 3469212 h 7067779"/>
                <a:gd name="connsiteX64" fmla="*/ 4838172 w 6542262"/>
                <a:gd name="connsiteY64" fmla="*/ 3459687 h 7067779"/>
                <a:gd name="connsiteX65" fmla="*/ 4942947 w 6542262"/>
                <a:gd name="connsiteY65" fmla="*/ 3621612 h 7067779"/>
                <a:gd name="connsiteX66" fmla="*/ 4914372 w 6542262"/>
                <a:gd name="connsiteY66" fmla="*/ 3554937 h 7067779"/>
                <a:gd name="connsiteX67" fmla="*/ 4914372 w 6542262"/>
                <a:gd name="connsiteY67" fmla="*/ 3688287 h 7067779"/>
                <a:gd name="connsiteX68" fmla="*/ 4781022 w 6542262"/>
                <a:gd name="connsiteY68" fmla="*/ 3812112 h 7067779"/>
                <a:gd name="connsiteX69" fmla="*/ 4895322 w 6542262"/>
                <a:gd name="connsiteY69" fmla="*/ 3888312 h 7067779"/>
                <a:gd name="connsiteX70" fmla="*/ 5171547 w 6542262"/>
                <a:gd name="connsiteY70" fmla="*/ 4459812 h 7067779"/>
                <a:gd name="connsiteX71" fmla="*/ 4466697 w 6542262"/>
                <a:gd name="connsiteY71" fmla="*/ 4736037 h 7067779"/>
                <a:gd name="connsiteX72" fmla="*/ 4409547 w 6542262"/>
                <a:gd name="connsiteY72" fmla="*/ 4812237 h 7067779"/>
                <a:gd name="connsiteX73" fmla="*/ 4247622 w 6542262"/>
                <a:gd name="connsiteY73" fmla="*/ 4964637 h 7067779"/>
                <a:gd name="connsiteX74" fmla="*/ 4057122 w 6542262"/>
                <a:gd name="connsiteY74" fmla="*/ 5050362 h 7067779"/>
                <a:gd name="connsiteX75" fmla="*/ 3923772 w 6542262"/>
                <a:gd name="connsiteY75" fmla="*/ 5088462 h 7067779"/>
                <a:gd name="connsiteX76" fmla="*/ 3647547 w 6542262"/>
                <a:gd name="connsiteY76" fmla="*/ 5117037 h 7067779"/>
                <a:gd name="connsiteX77" fmla="*/ 3171297 w 6542262"/>
                <a:gd name="connsiteY77" fmla="*/ 5136087 h 7067779"/>
                <a:gd name="connsiteX78" fmla="*/ 2771247 w 6542262"/>
                <a:gd name="connsiteY78" fmla="*/ 5050362 h 7067779"/>
                <a:gd name="connsiteX79" fmla="*/ 2456922 w 6542262"/>
                <a:gd name="connsiteY79" fmla="*/ 4878912 h 7067779"/>
                <a:gd name="connsiteX80" fmla="*/ 2152122 w 6542262"/>
                <a:gd name="connsiteY80" fmla="*/ 4736037 h 7067779"/>
                <a:gd name="connsiteX81" fmla="*/ 1990197 w 6542262"/>
                <a:gd name="connsiteY81" fmla="*/ 4440762 h 7067779"/>
                <a:gd name="connsiteX82" fmla="*/ 1856847 w 6542262"/>
                <a:gd name="connsiteY82" fmla="*/ 3869262 h 7067779"/>
                <a:gd name="connsiteX83" fmla="*/ 1818747 w 6542262"/>
                <a:gd name="connsiteY83" fmla="*/ 3621612 h 7067779"/>
                <a:gd name="connsiteX84" fmla="*/ 1085322 w 6542262"/>
                <a:gd name="connsiteY84" fmla="*/ 3497787 h 7067779"/>
                <a:gd name="connsiteX85" fmla="*/ 113772 w 6542262"/>
                <a:gd name="connsiteY85" fmla="*/ 3621612 h 706777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  <a:cxn ang="0">
                  <a:pos x="connsiteX55" y="connsiteY55"/>
                </a:cxn>
                <a:cxn ang="0">
                  <a:pos x="connsiteX56" y="connsiteY56"/>
                </a:cxn>
                <a:cxn ang="0">
                  <a:pos x="connsiteX57" y="connsiteY57"/>
                </a:cxn>
                <a:cxn ang="0">
                  <a:pos x="connsiteX58" y="connsiteY58"/>
                </a:cxn>
                <a:cxn ang="0">
                  <a:pos x="connsiteX59" y="connsiteY59"/>
                </a:cxn>
                <a:cxn ang="0">
                  <a:pos x="connsiteX60" y="connsiteY60"/>
                </a:cxn>
                <a:cxn ang="0">
                  <a:pos x="connsiteX61" y="connsiteY61"/>
                </a:cxn>
                <a:cxn ang="0">
                  <a:pos x="connsiteX62" y="connsiteY62"/>
                </a:cxn>
                <a:cxn ang="0">
                  <a:pos x="connsiteX63" y="connsiteY63"/>
                </a:cxn>
                <a:cxn ang="0">
                  <a:pos x="connsiteX64" y="connsiteY64"/>
                </a:cxn>
                <a:cxn ang="0">
                  <a:pos x="connsiteX65" y="connsiteY65"/>
                </a:cxn>
                <a:cxn ang="0">
                  <a:pos x="connsiteX66" y="connsiteY66"/>
                </a:cxn>
                <a:cxn ang="0">
                  <a:pos x="connsiteX67" y="connsiteY67"/>
                </a:cxn>
                <a:cxn ang="0">
                  <a:pos x="connsiteX68" y="connsiteY68"/>
                </a:cxn>
                <a:cxn ang="0">
                  <a:pos x="connsiteX69" y="connsiteY69"/>
                </a:cxn>
                <a:cxn ang="0">
                  <a:pos x="connsiteX70" y="connsiteY70"/>
                </a:cxn>
                <a:cxn ang="0">
                  <a:pos x="connsiteX71" y="connsiteY71"/>
                </a:cxn>
                <a:cxn ang="0">
                  <a:pos x="connsiteX72" y="connsiteY72"/>
                </a:cxn>
                <a:cxn ang="0">
                  <a:pos x="connsiteX73" y="connsiteY73"/>
                </a:cxn>
                <a:cxn ang="0">
                  <a:pos x="connsiteX74" y="connsiteY74"/>
                </a:cxn>
                <a:cxn ang="0">
                  <a:pos x="connsiteX75" y="connsiteY75"/>
                </a:cxn>
                <a:cxn ang="0">
                  <a:pos x="connsiteX76" y="connsiteY76"/>
                </a:cxn>
                <a:cxn ang="0">
                  <a:pos x="connsiteX77" y="connsiteY77"/>
                </a:cxn>
                <a:cxn ang="0">
                  <a:pos x="connsiteX78" y="connsiteY78"/>
                </a:cxn>
                <a:cxn ang="0">
                  <a:pos x="connsiteX79" y="connsiteY79"/>
                </a:cxn>
                <a:cxn ang="0">
                  <a:pos x="connsiteX80" y="connsiteY80"/>
                </a:cxn>
                <a:cxn ang="0">
                  <a:pos x="connsiteX81" y="connsiteY81"/>
                </a:cxn>
                <a:cxn ang="0">
                  <a:pos x="connsiteX82" y="connsiteY82"/>
                </a:cxn>
                <a:cxn ang="0">
                  <a:pos x="connsiteX83" y="connsiteY83"/>
                </a:cxn>
                <a:cxn ang="0">
                  <a:pos x="connsiteX84" y="connsiteY84"/>
                </a:cxn>
                <a:cxn ang="0">
                  <a:pos x="connsiteX85" y="connsiteY85"/>
                </a:cxn>
              </a:cxnLst>
              <a:rect l="l" t="t" r="r" b="b"/>
              <a:pathLst>
                <a:path w="6542262" h="7067779">
                  <a:moveTo>
                    <a:pt x="113772" y="3621612"/>
                  </a:moveTo>
                  <a:cubicBezTo>
                    <a:pt x="-64028" y="3875612"/>
                    <a:pt x="20109" y="4705875"/>
                    <a:pt x="18522" y="5021787"/>
                  </a:cubicBezTo>
                  <a:cubicBezTo>
                    <a:pt x="16935" y="5337699"/>
                    <a:pt x="-528" y="5390087"/>
                    <a:pt x="104247" y="5517087"/>
                  </a:cubicBezTo>
                  <a:cubicBezTo>
                    <a:pt x="209022" y="5644087"/>
                    <a:pt x="539222" y="5740925"/>
                    <a:pt x="647172" y="5783787"/>
                  </a:cubicBezTo>
                  <a:cubicBezTo>
                    <a:pt x="755122" y="5826650"/>
                    <a:pt x="655110" y="5755212"/>
                    <a:pt x="751947" y="5774262"/>
                  </a:cubicBezTo>
                  <a:cubicBezTo>
                    <a:pt x="848784" y="5793312"/>
                    <a:pt x="1069447" y="5833000"/>
                    <a:pt x="1228197" y="5898087"/>
                  </a:cubicBezTo>
                  <a:cubicBezTo>
                    <a:pt x="1386947" y="5963174"/>
                    <a:pt x="1544110" y="6082237"/>
                    <a:pt x="1704447" y="6164787"/>
                  </a:cubicBezTo>
                  <a:cubicBezTo>
                    <a:pt x="1864785" y="6247337"/>
                    <a:pt x="2061635" y="6337825"/>
                    <a:pt x="2190222" y="6393387"/>
                  </a:cubicBezTo>
                  <a:cubicBezTo>
                    <a:pt x="2318810" y="6448950"/>
                    <a:pt x="2415647" y="6402912"/>
                    <a:pt x="2475972" y="6498162"/>
                  </a:cubicBezTo>
                  <a:cubicBezTo>
                    <a:pt x="2536297" y="6593412"/>
                    <a:pt x="2498197" y="6872812"/>
                    <a:pt x="2552172" y="6964887"/>
                  </a:cubicBezTo>
                  <a:cubicBezTo>
                    <a:pt x="2606147" y="7056962"/>
                    <a:pt x="2693460" y="7091887"/>
                    <a:pt x="2799822" y="7050612"/>
                  </a:cubicBezTo>
                  <a:cubicBezTo>
                    <a:pt x="2906184" y="7009337"/>
                    <a:pt x="3071285" y="6774387"/>
                    <a:pt x="3190347" y="6717237"/>
                  </a:cubicBezTo>
                  <a:cubicBezTo>
                    <a:pt x="3309410" y="6660087"/>
                    <a:pt x="3318935" y="6722000"/>
                    <a:pt x="3514197" y="6707712"/>
                  </a:cubicBezTo>
                  <a:cubicBezTo>
                    <a:pt x="3709460" y="6693425"/>
                    <a:pt x="4111097" y="6695012"/>
                    <a:pt x="4361922" y="6631512"/>
                  </a:cubicBezTo>
                  <a:cubicBezTo>
                    <a:pt x="4612747" y="6568012"/>
                    <a:pt x="4796897" y="6501337"/>
                    <a:pt x="5019147" y="6326712"/>
                  </a:cubicBezTo>
                  <a:cubicBezTo>
                    <a:pt x="5241397" y="6152087"/>
                    <a:pt x="5598585" y="5744099"/>
                    <a:pt x="5695422" y="5583762"/>
                  </a:cubicBezTo>
                  <a:cubicBezTo>
                    <a:pt x="5792259" y="5423425"/>
                    <a:pt x="5535085" y="5432949"/>
                    <a:pt x="5600172" y="5364687"/>
                  </a:cubicBezTo>
                  <a:cubicBezTo>
                    <a:pt x="5665259" y="5296425"/>
                    <a:pt x="5995460" y="5261499"/>
                    <a:pt x="6085947" y="5174187"/>
                  </a:cubicBezTo>
                  <a:cubicBezTo>
                    <a:pt x="6176434" y="5086875"/>
                    <a:pt x="6124047" y="4967812"/>
                    <a:pt x="6143097" y="4840812"/>
                  </a:cubicBezTo>
                  <a:cubicBezTo>
                    <a:pt x="6162147" y="4713812"/>
                    <a:pt x="6149447" y="4489975"/>
                    <a:pt x="6200247" y="4412187"/>
                  </a:cubicBezTo>
                  <a:cubicBezTo>
                    <a:pt x="6251047" y="4334400"/>
                    <a:pt x="6392335" y="4412187"/>
                    <a:pt x="6447897" y="4374087"/>
                  </a:cubicBezTo>
                  <a:cubicBezTo>
                    <a:pt x="6503459" y="4335987"/>
                    <a:pt x="6565372" y="4278837"/>
                    <a:pt x="6533622" y="4183587"/>
                  </a:cubicBezTo>
                  <a:cubicBezTo>
                    <a:pt x="6501872" y="4088337"/>
                    <a:pt x="6308197" y="3948637"/>
                    <a:pt x="6257397" y="3802587"/>
                  </a:cubicBezTo>
                  <a:cubicBezTo>
                    <a:pt x="6206597" y="3656537"/>
                    <a:pt x="6243109" y="3510487"/>
                    <a:pt x="6228822" y="3307287"/>
                  </a:cubicBezTo>
                  <a:cubicBezTo>
                    <a:pt x="6214535" y="3104087"/>
                    <a:pt x="6228822" y="2854849"/>
                    <a:pt x="6171672" y="2583387"/>
                  </a:cubicBezTo>
                  <a:cubicBezTo>
                    <a:pt x="6114522" y="2311924"/>
                    <a:pt x="5971647" y="1980137"/>
                    <a:pt x="5885922" y="1678512"/>
                  </a:cubicBezTo>
                  <a:cubicBezTo>
                    <a:pt x="5800197" y="1376887"/>
                    <a:pt x="5760510" y="989537"/>
                    <a:pt x="5657322" y="773637"/>
                  </a:cubicBezTo>
                  <a:cubicBezTo>
                    <a:pt x="5554135" y="557737"/>
                    <a:pt x="5422372" y="437087"/>
                    <a:pt x="5266797" y="383112"/>
                  </a:cubicBezTo>
                  <a:cubicBezTo>
                    <a:pt x="5111222" y="329137"/>
                    <a:pt x="4887385" y="500587"/>
                    <a:pt x="4723872" y="449787"/>
                  </a:cubicBezTo>
                  <a:cubicBezTo>
                    <a:pt x="4560360" y="398987"/>
                    <a:pt x="4485747" y="137049"/>
                    <a:pt x="4285722" y="78312"/>
                  </a:cubicBezTo>
                  <a:cubicBezTo>
                    <a:pt x="4085697" y="19575"/>
                    <a:pt x="3739622" y="98949"/>
                    <a:pt x="3523722" y="97362"/>
                  </a:cubicBezTo>
                  <a:cubicBezTo>
                    <a:pt x="3307822" y="95775"/>
                    <a:pt x="3144309" y="81487"/>
                    <a:pt x="2990322" y="68787"/>
                  </a:cubicBezTo>
                  <a:cubicBezTo>
                    <a:pt x="2836335" y="56087"/>
                    <a:pt x="2768072" y="-42338"/>
                    <a:pt x="2599797" y="21162"/>
                  </a:cubicBezTo>
                  <a:cubicBezTo>
                    <a:pt x="2431522" y="84662"/>
                    <a:pt x="2155297" y="335487"/>
                    <a:pt x="1980672" y="449787"/>
                  </a:cubicBezTo>
                  <a:cubicBezTo>
                    <a:pt x="1806047" y="564087"/>
                    <a:pt x="1666347" y="606949"/>
                    <a:pt x="1552047" y="706962"/>
                  </a:cubicBezTo>
                  <a:cubicBezTo>
                    <a:pt x="1437747" y="806974"/>
                    <a:pt x="1359959" y="941912"/>
                    <a:pt x="1294872" y="1049862"/>
                  </a:cubicBezTo>
                  <a:cubicBezTo>
                    <a:pt x="1229785" y="1157812"/>
                    <a:pt x="1234547" y="1195912"/>
                    <a:pt x="1161522" y="1354662"/>
                  </a:cubicBezTo>
                  <a:cubicBezTo>
                    <a:pt x="1088497" y="1513412"/>
                    <a:pt x="918634" y="1784875"/>
                    <a:pt x="856722" y="2002362"/>
                  </a:cubicBezTo>
                  <a:cubicBezTo>
                    <a:pt x="794810" y="2219849"/>
                    <a:pt x="805922" y="2467500"/>
                    <a:pt x="790047" y="2659587"/>
                  </a:cubicBezTo>
                  <a:cubicBezTo>
                    <a:pt x="774172" y="2851674"/>
                    <a:pt x="688447" y="3075512"/>
                    <a:pt x="761472" y="3154887"/>
                  </a:cubicBezTo>
                  <a:cubicBezTo>
                    <a:pt x="834497" y="3234262"/>
                    <a:pt x="961497" y="3202512"/>
                    <a:pt x="1228197" y="3135837"/>
                  </a:cubicBezTo>
                  <a:cubicBezTo>
                    <a:pt x="1494897" y="3069162"/>
                    <a:pt x="2166410" y="2819924"/>
                    <a:pt x="2361672" y="2754837"/>
                  </a:cubicBezTo>
                  <a:cubicBezTo>
                    <a:pt x="2556935" y="2689749"/>
                    <a:pt x="2398185" y="2767537"/>
                    <a:pt x="2399772" y="2745312"/>
                  </a:cubicBezTo>
                  <a:cubicBezTo>
                    <a:pt x="2401359" y="2723087"/>
                    <a:pt x="2372785" y="2672287"/>
                    <a:pt x="2371197" y="2621487"/>
                  </a:cubicBezTo>
                  <a:cubicBezTo>
                    <a:pt x="2369610" y="2570687"/>
                    <a:pt x="2377547" y="2489724"/>
                    <a:pt x="2390247" y="2440512"/>
                  </a:cubicBezTo>
                  <a:cubicBezTo>
                    <a:pt x="2402947" y="2391300"/>
                    <a:pt x="2418822" y="2370662"/>
                    <a:pt x="2447397" y="2326212"/>
                  </a:cubicBezTo>
                  <a:cubicBezTo>
                    <a:pt x="2475972" y="2281762"/>
                    <a:pt x="2491847" y="2211912"/>
                    <a:pt x="2561697" y="2173812"/>
                  </a:cubicBezTo>
                  <a:cubicBezTo>
                    <a:pt x="2631547" y="2135712"/>
                    <a:pt x="2780772" y="2118249"/>
                    <a:pt x="2866497" y="2097612"/>
                  </a:cubicBezTo>
                  <a:cubicBezTo>
                    <a:pt x="2952222" y="2076975"/>
                    <a:pt x="3010960" y="2062687"/>
                    <a:pt x="3076047" y="2049987"/>
                  </a:cubicBezTo>
                  <a:cubicBezTo>
                    <a:pt x="3141134" y="2037287"/>
                    <a:pt x="3215747" y="2040462"/>
                    <a:pt x="3257022" y="2021412"/>
                  </a:cubicBezTo>
                  <a:cubicBezTo>
                    <a:pt x="3298297" y="2002362"/>
                    <a:pt x="3293535" y="1934100"/>
                    <a:pt x="3323697" y="1935687"/>
                  </a:cubicBezTo>
                  <a:cubicBezTo>
                    <a:pt x="3353859" y="1937274"/>
                    <a:pt x="3393547" y="2021412"/>
                    <a:pt x="3437997" y="2030937"/>
                  </a:cubicBezTo>
                  <a:cubicBezTo>
                    <a:pt x="3482447" y="2040462"/>
                    <a:pt x="3553885" y="2021412"/>
                    <a:pt x="3590397" y="1992837"/>
                  </a:cubicBezTo>
                  <a:cubicBezTo>
                    <a:pt x="3626909" y="1964262"/>
                    <a:pt x="3611034" y="1865837"/>
                    <a:pt x="3657072" y="1859487"/>
                  </a:cubicBezTo>
                  <a:cubicBezTo>
                    <a:pt x="3703110" y="1853137"/>
                    <a:pt x="3790422" y="1930925"/>
                    <a:pt x="3866622" y="1954737"/>
                  </a:cubicBezTo>
                  <a:cubicBezTo>
                    <a:pt x="3942822" y="1978549"/>
                    <a:pt x="4053947" y="1973787"/>
                    <a:pt x="4114272" y="2002362"/>
                  </a:cubicBezTo>
                  <a:cubicBezTo>
                    <a:pt x="4174597" y="2030937"/>
                    <a:pt x="4176185" y="2073800"/>
                    <a:pt x="4228572" y="2126187"/>
                  </a:cubicBezTo>
                  <a:cubicBezTo>
                    <a:pt x="4280959" y="2178574"/>
                    <a:pt x="4387322" y="2242075"/>
                    <a:pt x="4428597" y="2316687"/>
                  </a:cubicBezTo>
                  <a:cubicBezTo>
                    <a:pt x="4469872" y="2391299"/>
                    <a:pt x="4447647" y="2488137"/>
                    <a:pt x="4476222" y="2573862"/>
                  </a:cubicBezTo>
                  <a:cubicBezTo>
                    <a:pt x="4504797" y="2659587"/>
                    <a:pt x="4544485" y="2711975"/>
                    <a:pt x="4600047" y="2831037"/>
                  </a:cubicBezTo>
                  <a:cubicBezTo>
                    <a:pt x="4655609" y="2950099"/>
                    <a:pt x="4761972" y="3192987"/>
                    <a:pt x="4809597" y="3288237"/>
                  </a:cubicBezTo>
                  <a:cubicBezTo>
                    <a:pt x="4857222" y="3383487"/>
                    <a:pt x="4871510" y="3361262"/>
                    <a:pt x="4885797" y="3402537"/>
                  </a:cubicBezTo>
                  <a:cubicBezTo>
                    <a:pt x="4900085" y="3443812"/>
                    <a:pt x="4890560" y="3524775"/>
                    <a:pt x="4895322" y="3535887"/>
                  </a:cubicBezTo>
                  <a:cubicBezTo>
                    <a:pt x="4900084" y="3546999"/>
                    <a:pt x="4923897" y="3481912"/>
                    <a:pt x="4914372" y="3469212"/>
                  </a:cubicBezTo>
                  <a:cubicBezTo>
                    <a:pt x="4904847" y="3456512"/>
                    <a:pt x="4833410" y="3434287"/>
                    <a:pt x="4838172" y="3459687"/>
                  </a:cubicBezTo>
                  <a:cubicBezTo>
                    <a:pt x="4842934" y="3485087"/>
                    <a:pt x="4930247" y="3605737"/>
                    <a:pt x="4942947" y="3621612"/>
                  </a:cubicBezTo>
                  <a:cubicBezTo>
                    <a:pt x="4955647" y="3637487"/>
                    <a:pt x="4919134" y="3543825"/>
                    <a:pt x="4914372" y="3554937"/>
                  </a:cubicBezTo>
                  <a:cubicBezTo>
                    <a:pt x="4909610" y="3566049"/>
                    <a:pt x="4936597" y="3645425"/>
                    <a:pt x="4914372" y="3688287"/>
                  </a:cubicBezTo>
                  <a:cubicBezTo>
                    <a:pt x="4892147" y="3731149"/>
                    <a:pt x="4784197" y="3778775"/>
                    <a:pt x="4781022" y="3812112"/>
                  </a:cubicBezTo>
                  <a:cubicBezTo>
                    <a:pt x="4777847" y="3845449"/>
                    <a:pt x="4830235" y="3780362"/>
                    <a:pt x="4895322" y="3888312"/>
                  </a:cubicBezTo>
                  <a:cubicBezTo>
                    <a:pt x="4960409" y="3996262"/>
                    <a:pt x="5242984" y="4318525"/>
                    <a:pt x="5171547" y="4459812"/>
                  </a:cubicBezTo>
                  <a:cubicBezTo>
                    <a:pt x="5100110" y="4601099"/>
                    <a:pt x="4593697" y="4677300"/>
                    <a:pt x="4466697" y="4736037"/>
                  </a:cubicBezTo>
                  <a:cubicBezTo>
                    <a:pt x="4339697" y="4794775"/>
                    <a:pt x="4446059" y="4774137"/>
                    <a:pt x="4409547" y="4812237"/>
                  </a:cubicBezTo>
                  <a:cubicBezTo>
                    <a:pt x="4373035" y="4850337"/>
                    <a:pt x="4306359" y="4924950"/>
                    <a:pt x="4247622" y="4964637"/>
                  </a:cubicBezTo>
                  <a:cubicBezTo>
                    <a:pt x="4188885" y="5004324"/>
                    <a:pt x="4111097" y="5029725"/>
                    <a:pt x="4057122" y="5050362"/>
                  </a:cubicBezTo>
                  <a:cubicBezTo>
                    <a:pt x="4003147" y="5071000"/>
                    <a:pt x="3992034" y="5077350"/>
                    <a:pt x="3923772" y="5088462"/>
                  </a:cubicBezTo>
                  <a:cubicBezTo>
                    <a:pt x="3855510" y="5099574"/>
                    <a:pt x="3772959" y="5109100"/>
                    <a:pt x="3647547" y="5117037"/>
                  </a:cubicBezTo>
                  <a:cubicBezTo>
                    <a:pt x="3522135" y="5124974"/>
                    <a:pt x="3317347" y="5147199"/>
                    <a:pt x="3171297" y="5136087"/>
                  </a:cubicBezTo>
                  <a:cubicBezTo>
                    <a:pt x="3025247" y="5124975"/>
                    <a:pt x="2890310" y="5093225"/>
                    <a:pt x="2771247" y="5050362"/>
                  </a:cubicBezTo>
                  <a:cubicBezTo>
                    <a:pt x="2652185" y="5007500"/>
                    <a:pt x="2560109" y="4931299"/>
                    <a:pt x="2456922" y="4878912"/>
                  </a:cubicBezTo>
                  <a:cubicBezTo>
                    <a:pt x="2353735" y="4826525"/>
                    <a:pt x="2229910" y="4809062"/>
                    <a:pt x="2152122" y="4736037"/>
                  </a:cubicBezTo>
                  <a:cubicBezTo>
                    <a:pt x="2074335" y="4663012"/>
                    <a:pt x="2039410" y="4585225"/>
                    <a:pt x="1990197" y="4440762"/>
                  </a:cubicBezTo>
                  <a:cubicBezTo>
                    <a:pt x="1940984" y="4296299"/>
                    <a:pt x="1885422" y="4005787"/>
                    <a:pt x="1856847" y="3869262"/>
                  </a:cubicBezTo>
                  <a:cubicBezTo>
                    <a:pt x="1828272" y="3732737"/>
                    <a:pt x="1947334" y="3683524"/>
                    <a:pt x="1818747" y="3621612"/>
                  </a:cubicBezTo>
                  <a:cubicBezTo>
                    <a:pt x="1690160" y="3559700"/>
                    <a:pt x="1363134" y="3499374"/>
                    <a:pt x="1085322" y="3497787"/>
                  </a:cubicBezTo>
                  <a:cubicBezTo>
                    <a:pt x="807510" y="3496200"/>
                    <a:pt x="291572" y="3367612"/>
                    <a:pt x="113772" y="3621612"/>
                  </a:cubicBez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97" name="矩形 296"/>
            <p:cNvSpPr/>
            <p:nvPr/>
          </p:nvSpPr>
          <p:spPr>
            <a:xfrm rot="5128728">
              <a:off x="5835848" y="4534880"/>
              <a:ext cx="1536409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dirty="0">
                  <a:latin typeface="Arial" panose="020B0604020202020204" pitchFamily="34" charset="0"/>
                  <a:cs typeface="Arial" panose="020B0604020202020204" pitchFamily="34" charset="0"/>
                </a:rPr>
                <a:t>Mammals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" name="Rectangle 2"/>
            <p:cNvSpPr/>
            <p:nvPr/>
          </p:nvSpPr>
          <p:spPr>
            <a:xfrm>
              <a:off x="835025" y="8074025"/>
              <a:ext cx="532995" cy="50121"/>
            </a:xfrm>
            <a:prstGeom prst="rect">
              <a:avLst/>
            </a:prstGeom>
            <a:solidFill>
              <a:schemeClr val="bg1"/>
            </a:solidFill>
            <a:ln w="4445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Rectangle 24"/>
            <p:cNvSpPr/>
            <p:nvPr/>
          </p:nvSpPr>
          <p:spPr>
            <a:xfrm>
              <a:off x="1250545" y="8074025"/>
              <a:ext cx="117475" cy="53296"/>
            </a:xfrm>
            <a:prstGeom prst="rect">
              <a:avLst/>
            </a:prstGeom>
            <a:solidFill>
              <a:schemeClr val="bg1"/>
            </a:solidFill>
            <a:ln w="4445"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929040" y="8082717"/>
              <a:ext cx="344966" cy="2308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charset="0"/>
                  <a:ea typeface="Arial" charset="0"/>
                  <a:cs typeface="Arial" charset="0"/>
                </a:rPr>
                <a:t>0.1</a:t>
              </a:r>
            </a:p>
          </p:txBody>
        </p:sp>
        <p:sp>
          <p:nvSpPr>
            <p:cNvPr id="2" name="文本框 1"/>
            <p:cNvSpPr txBox="1"/>
            <p:nvPr/>
          </p:nvSpPr>
          <p:spPr>
            <a:xfrm rot="8667813">
              <a:off x="4276503" y="2925087"/>
              <a:ext cx="22477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hlamydomon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einhardtii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Cre13.g56710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文本框 26"/>
            <p:cNvSpPr txBox="1"/>
            <p:nvPr/>
          </p:nvSpPr>
          <p:spPr>
            <a:xfrm rot="18015199">
              <a:off x="960784" y="6865877"/>
              <a:ext cx="224773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hlamydomon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einhardtii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Cre14.g61165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 rot="18709427">
              <a:off x="1127906" y="6417797"/>
              <a:ext cx="16193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olvox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rteri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294801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/>
            <p:cNvSpPr txBox="1"/>
            <p:nvPr/>
          </p:nvSpPr>
          <p:spPr>
            <a:xfrm rot="8051643">
              <a:off x="4162568" y="2677657"/>
              <a:ext cx="189346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unaliell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alin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Dusal.0407s00017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/>
            <p:cNvSpPr txBox="1"/>
            <p:nvPr/>
          </p:nvSpPr>
          <p:spPr>
            <a:xfrm rot="4422061">
              <a:off x="2002734" y="2210521"/>
              <a:ext cx="22156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occomyx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ellipsoidea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 (XP_005644279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 rot="5012270">
              <a:off x="2571410" y="2263826"/>
              <a:ext cx="17700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lorell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orokinian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PRW32883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 rot="5812851">
              <a:off x="2852911" y="2312892"/>
              <a:ext cx="18293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lorell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ariabil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5843316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 rot="6289254">
              <a:off x="3160981" y="2117142"/>
              <a:ext cx="19287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aphidocel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capitat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GBF99677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 rot="7510471">
              <a:off x="3828809" y="2360308"/>
              <a:ext cx="20361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romon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ommod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250187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 rot="17666941">
              <a:off x="1978692" y="6774578"/>
              <a:ext cx="1508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.zofingiens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Cz07g3218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 rot="7093893">
              <a:off x="3605528" y="2505499"/>
              <a:ext cx="15087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.zofingiens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Cz16g2105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 rot="19366511">
              <a:off x="581946" y="6274601"/>
              <a:ext cx="192873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aphidocel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capitat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GBF99231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 rot="19712085">
              <a:off x="132729" y="5970537"/>
              <a:ext cx="221567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occomyx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ubellipsoide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5649645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 rot="9391679">
              <a:off x="4513953" y="3378152"/>
              <a:ext cx="16193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olvox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rteri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2945634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 rot="20661227">
              <a:off x="967666" y="3989520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rabidopsis thaliana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190376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 rot="17147763">
              <a:off x="2046883" y="7035917"/>
              <a:ext cx="19832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Saccharomyces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erevisiae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AJS9669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 rot="1216979">
              <a:off x="1028994" y="3369631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Brassic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ap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3685289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 rot="2603845">
              <a:off x="1170458" y="2772694"/>
              <a:ext cx="185499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icotian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abacum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001312725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 rot="316867">
              <a:off x="841258" y="3655317"/>
              <a:ext cx="17347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psell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rubella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629033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 rot="3616711">
              <a:off x="3752879" y="6850964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Arabidopsis thaliana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20046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 rot="3516788">
              <a:off x="1366849" y="2542774"/>
              <a:ext cx="192392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olanum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tuberosum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00127532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 rot="4177779">
              <a:off x="2066022" y="2629123"/>
              <a:ext cx="14526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Ze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mays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001167748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/>
            <p:cNvSpPr txBox="1"/>
            <p:nvPr/>
          </p:nvSpPr>
          <p:spPr>
            <a:xfrm rot="1996228">
              <a:off x="1146225" y="3035526"/>
              <a:ext cx="17299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Jatroph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urc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2085977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/>
            <p:cNvSpPr txBox="1"/>
            <p:nvPr/>
          </p:nvSpPr>
          <p:spPr>
            <a:xfrm rot="5400000">
              <a:off x="3160603" y="6997204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Brassic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nap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371442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/>
            <p:cNvSpPr txBox="1"/>
            <p:nvPr/>
          </p:nvSpPr>
          <p:spPr>
            <a:xfrm rot="4525995">
              <a:off x="3465092" y="6940553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psell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rubella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6280234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 rot="2207873">
              <a:off x="4333425" y="6347312"/>
              <a:ext cx="175721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Jatroph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urc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2083815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 rot="2957079">
              <a:off x="4151983" y="6533076"/>
              <a:ext cx="156164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Glycine max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3548404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 rot="6497411">
              <a:off x="2795966" y="6995054"/>
              <a:ext cx="181652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Raphan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ativ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8453557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 rot="19694004">
              <a:off x="4855804" y="4038518"/>
              <a:ext cx="166744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orex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rane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461479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 rot="2278337">
              <a:off x="4940254" y="5300385"/>
              <a:ext cx="157927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rcin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orca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4270744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5055161" y="4690464"/>
              <a:ext cx="14847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Fel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at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1968415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文本框 58"/>
            <p:cNvSpPr txBox="1"/>
            <p:nvPr/>
          </p:nvSpPr>
          <p:spPr>
            <a:xfrm rot="3362578">
              <a:off x="4587547" y="5633038"/>
              <a:ext cx="201689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Delphinapter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euc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22450701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任意多边形 8"/>
            <p:cNvSpPr/>
            <p:nvPr/>
          </p:nvSpPr>
          <p:spPr>
            <a:xfrm>
              <a:off x="5069476" y="4612812"/>
              <a:ext cx="91084" cy="245930"/>
            </a:xfrm>
            <a:custGeom>
              <a:avLst/>
              <a:gdLst>
                <a:gd name="connsiteX0" fmla="*/ 4079 w 91084"/>
                <a:gd name="connsiteY0" fmla="*/ 131 h 245930"/>
                <a:gd name="connsiteX1" fmla="*/ 85966 w 91084"/>
                <a:gd name="connsiteY1" fmla="*/ 75194 h 245930"/>
                <a:gd name="connsiteX2" fmla="*/ 79142 w 91084"/>
                <a:gd name="connsiteY2" fmla="*/ 204848 h 245930"/>
                <a:gd name="connsiteX3" fmla="*/ 51846 w 91084"/>
                <a:gd name="connsiteY3" fmla="*/ 245791 h 245930"/>
                <a:gd name="connsiteX4" fmla="*/ 34787 w 91084"/>
                <a:gd name="connsiteY4" fmla="*/ 218495 h 245930"/>
                <a:gd name="connsiteX5" fmla="*/ 27963 w 91084"/>
                <a:gd name="connsiteY5" fmla="*/ 225319 h 245930"/>
                <a:gd name="connsiteX6" fmla="*/ 14315 w 91084"/>
                <a:gd name="connsiteY6" fmla="*/ 92254 h 245930"/>
                <a:gd name="connsiteX7" fmla="*/ 4079 w 91084"/>
                <a:gd name="connsiteY7" fmla="*/ 131 h 24593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91084" h="245930">
                  <a:moveTo>
                    <a:pt x="4079" y="131"/>
                  </a:moveTo>
                  <a:cubicBezTo>
                    <a:pt x="16021" y="-2712"/>
                    <a:pt x="73455" y="41074"/>
                    <a:pt x="85966" y="75194"/>
                  </a:cubicBezTo>
                  <a:cubicBezTo>
                    <a:pt x="98477" y="109314"/>
                    <a:pt x="84829" y="176415"/>
                    <a:pt x="79142" y="204848"/>
                  </a:cubicBezTo>
                  <a:cubicBezTo>
                    <a:pt x="73455" y="233281"/>
                    <a:pt x="59238" y="243517"/>
                    <a:pt x="51846" y="245791"/>
                  </a:cubicBezTo>
                  <a:cubicBezTo>
                    <a:pt x="44454" y="248065"/>
                    <a:pt x="38768" y="221907"/>
                    <a:pt x="34787" y="218495"/>
                  </a:cubicBezTo>
                  <a:cubicBezTo>
                    <a:pt x="30807" y="215083"/>
                    <a:pt x="31375" y="246359"/>
                    <a:pt x="27963" y="225319"/>
                  </a:cubicBezTo>
                  <a:cubicBezTo>
                    <a:pt x="24551" y="204279"/>
                    <a:pt x="18864" y="125805"/>
                    <a:pt x="14315" y="92254"/>
                  </a:cubicBezTo>
                  <a:cubicBezTo>
                    <a:pt x="9766" y="58703"/>
                    <a:pt x="-7863" y="2974"/>
                    <a:pt x="4079" y="131"/>
                  </a:cubicBezTo>
                  <a:close/>
                </a:path>
              </a:pathLst>
            </a:cu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4" name="文本框 53"/>
            <p:cNvSpPr txBox="1"/>
            <p:nvPr/>
          </p:nvSpPr>
          <p:spPr>
            <a:xfrm rot="20488043">
              <a:off x="4985823" y="4367332"/>
              <a:ext cx="14847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usculu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NP_84886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矩形 297"/>
            <p:cNvSpPr/>
            <p:nvPr/>
          </p:nvSpPr>
          <p:spPr>
            <a:xfrm rot="1430768">
              <a:off x="2622789" y="6189687"/>
              <a:ext cx="170955" cy="1523912"/>
            </a:xfrm>
            <a:prstGeom prst="rect">
              <a:avLst/>
            </a:prstGeom>
            <a:noFill/>
            <a:ln>
              <a:solidFill>
                <a:srgbClr val="7030A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5" name="任意多边形 284"/>
            <p:cNvSpPr/>
            <p:nvPr/>
          </p:nvSpPr>
          <p:spPr>
            <a:xfrm>
              <a:off x="760534" y="1610540"/>
              <a:ext cx="2415110" cy="2914931"/>
            </a:xfrm>
            <a:custGeom>
              <a:avLst/>
              <a:gdLst>
                <a:gd name="connsiteX0" fmla="*/ 2294502 w 2296527"/>
                <a:gd name="connsiteY0" fmla="*/ 1519012 h 2792761"/>
                <a:gd name="connsiteX1" fmla="*/ 1645915 w 2296527"/>
                <a:gd name="connsiteY1" fmla="*/ 19821 h 2792761"/>
                <a:gd name="connsiteX2" fmla="*/ 370008 w 2296527"/>
                <a:gd name="connsiteY2" fmla="*/ 795998 h 2792761"/>
                <a:gd name="connsiteX3" fmla="*/ 93562 w 2296527"/>
                <a:gd name="connsiteY3" fmla="*/ 2699226 h 2792761"/>
                <a:gd name="connsiteX4" fmla="*/ 1784139 w 2296527"/>
                <a:gd name="connsiteY4" fmla="*/ 2401514 h 2792761"/>
                <a:gd name="connsiteX5" fmla="*/ 2294502 w 2296527"/>
                <a:gd name="connsiteY5" fmla="*/ 1519012 h 279276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</a:cxnLst>
              <a:rect l="l" t="t" r="r" b="b"/>
              <a:pathLst>
                <a:path w="2296527" h="2792761">
                  <a:moveTo>
                    <a:pt x="2294502" y="1519012"/>
                  </a:moveTo>
                  <a:cubicBezTo>
                    <a:pt x="2271465" y="1122063"/>
                    <a:pt x="1966664" y="140323"/>
                    <a:pt x="1645915" y="19821"/>
                  </a:cubicBezTo>
                  <a:cubicBezTo>
                    <a:pt x="1325166" y="-100681"/>
                    <a:pt x="628733" y="349431"/>
                    <a:pt x="370008" y="795998"/>
                  </a:cubicBezTo>
                  <a:cubicBezTo>
                    <a:pt x="111283" y="1242565"/>
                    <a:pt x="-142126" y="2431640"/>
                    <a:pt x="93562" y="2699226"/>
                  </a:cubicBezTo>
                  <a:cubicBezTo>
                    <a:pt x="329250" y="2966812"/>
                    <a:pt x="1424404" y="2594672"/>
                    <a:pt x="1784139" y="2401514"/>
                  </a:cubicBezTo>
                  <a:cubicBezTo>
                    <a:pt x="2143874" y="2208356"/>
                    <a:pt x="2317539" y="1915961"/>
                    <a:pt x="2294502" y="1519012"/>
                  </a:cubicBezTo>
                  <a:close/>
                </a:path>
              </a:pathLst>
            </a:custGeom>
            <a:solidFill>
              <a:schemeClr val="accent2">
                <a:lumMod val="40000"/>
                <a:lumOff val="60000"/>
                <a:alpha val="28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9" name="任意多边形 288"/>
            <p:cNvSpPr/>
            <p:nvPr/>
          </p:nvSpPr>
          <p:spPr>
            <a:xfrm>
              <a:off x="57406" y="4523196"/>
              <a:ext cx="3306378" cy="3649073"/>
            </a:xfrm>
            <a:custGeom>
              <a:avLst/>
              <a:gdLst>
                <a:gd name="connsiteX0" fmla="*/ 2608494 w 3030905"/>
                <a:gd name="connsiteY0" fmla="*/ 1064066 h 3081392"/>
                <a:gd name="connsiteX1" fmla="*/ 2083708 w 3030905"/>
                <a:gd name="connsiteY1" fmla="*/ 245081 h 3081392"/>
                <a:gd name="connsiteX2" fmla="*/ 318518 w 3030905"/>
                <a:gd name="connsiteY2" fmla="*/ 141714 h 3081392"/>
                <a:gd name="connsiteX3" fmla="*/ 207200 w 3030905"/>
                <a:gd name="connsiteY3" fmla="*/ 2057979 h 3081392"/>
                <a:gd name="connsiteX4" fmla="*/ 2489224 w 3030905"/>
                <a:gd name="connsiteY4" fmla="*/ 3075746 h 3081392"/>
                <a:gd name="connsiteX5" fmla="*/ 3029913 w 3030905"/>
                <a:gd name="connsiteY5" fmla="*/ 1636560 h 3081392"/>
                <a:gd name="connsiteX6" fmla="*/ 2608494 w 3030905"/>
                <a:gd name="connsiteY6" fmla="*/ 1064066 h 308139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030905" h="3081392">
                  <a:moveTo>
                    <a:pt x="2608494" y="1064066"/>
                  </a:moveTo>
                  <a:cubicBezTo>
                    <a:pt x="2450793" y="832153"/>
                    <a:pt x="2465371" y="398806"/>
                    <a:pt x="2083708" y="245081"/>
                  </a:cubicBezTo>
                  <a:cubicBezTo>
                    <a:pt x="1702045" y="91356"/>
                    <a:pt x="631269" y="-160436"/>
                    <a:pt x="318518" y="141714"/>
                  </a:cubicBezTo>
                  <a:cubicBezTo>
                    <a:pt x="5767" y="443864"/>
                    <a:pt x="-154584" y="1568974"/>
                    <a:pt x="207200" y="2057979"/>
                  </a:cubicBezTo>
                  <a:cubicBezTo>
                    <a:pt x="568984" y="2546984"/>
                    <a:pt x="2018772" y="3145983"/>
                    <a:pt x="2489224" y="3075746"/>
                  </a:cubicBezTo>
                  <a:cubicBezTo>
                    <a:pt x="2959676" y="3005510"/>
                    <a:pt x="3010035" y="1979791"/>
                    <a:pt x="3029913" y="1636560"/>
                  </a:cubicBezTo>
                  <a:cubicBezTo>
                    <a:pt x="3049791" y="1293329"/>
                    <a:pt x="2766195" y="1295979"/>
                    <a:pt x="2608494" y="1064066"/>
                  </a:cubicBezTo>
                  <a:close/>
                </a:path>
              </a:pathLst>
            </a:custGeom>
            <a:solidFill>
              <a:schemeClr val="accent1">
                <a:alpha val="24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61" name="文本框 60"/>
            <p:cNvSpPr txBox="1"/>
            <p:nvPr/>
          </p:nvSpPr>
          <p:spPr>
            <a:xfrm rot="244181">
              <a:off x="267839" y="4787800"/>
              <a:ext cx="18293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Chlorell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variabili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5849609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 rot="21366712">
              <a:off x="347619" y="5062311"/>
              <a:ext cx="18293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hlorella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orokinian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PRW58756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 rot="20767855">
              <a:off x="370276" y="5409071"/>
              <a:ext cx="18293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Micromonas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conductrix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PSC73742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任意多边形 287"/>
            <p:cNvSpPr/>
            <p:nvPr/>
          </p:nvSpPr>
          <p:spPr>
            <a:xfrm>
              <a:off x="3267560" y="5713159"/>
              <a:ext cx="2706141" cy="2359477"/>
            </a:xfrm>
            <a:custGeom>
              <a:avLst/>
              <a:gdLst>
                <a:gd name="connsiteX0" fmla="*/ 1419775 w 2706141"/>
                <a:gd name="connsiteY0" fmla="*/ 2043658 h 2250686"/>
                <a:gd name="connsiteX1" fmla="*/ 2469347 w 2706141"/>
                <a:gd name="connsiteY1" fmla="*/ 1534774 h 2250686"/>
                <a:gd name="connsiteX2" fmla="*/ 2612471 w 2706141"/>
                <a:gd name="connsiteY2" fmla="*/ 978183 h 2250686"/>
                <a:gd name="connsiteX3" fmla="*/ 1300505 w 2706141"/>
                <a:gd name="connsiteY3" fmla="*/ 87637 h 2250686"/>
                <a:gd name="connsiteX4" fmla="*/ 640547 w 2706141"/>
                <a:gd name="connsiteY4" fmla="*/ 262565 h 2250686"/>
                <a:gd name="connsiteX5" fmla="*/ 20345 w 2706141"/>
                <a:gd name="connsiteY5" fmla="*/ 2115219 h 2250686"/>
                <a:gd name="connsiteX6" fmla="*/ 1419775 w 2706141"/>
                <a:gd name="connsiteY6" fmla="*/ 2043658 h 225068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706141" h="2250686">
                  <a:moveTo>
                    <a:pt x="1419775" y="2043658"/>
                  </a:moveTo>
                  <a:cubicBezTo>
                    <a:pt x="1827942" y="1946917"/>
                    <a:pt x="2270564" y="1712353"/>
                    <a:pt x="2469347" y="1534774"/>
                  </a:cubicBezTo>
                  <a:cubicBezTo>
                    <a:pt x="2668130" y="1357195"/>
                    <a:pt x="2807278" y="1219372"/>
                    <a:pt x="2612471" y="978183"/>
                  </a:cubicBezTo>
                  <a:cubicBezTo>
                    <a:pt x="2417664" y="736994"/>
                    <a:pt x="1629159" y="206907"/>
                    <a:pt x="1300505" y="87637"/>
                  </a:cubicBezTo>
                  <a:cubicBezTo>
                    <a:pt x="971851" y="-31633"/>
                    <a:pt x="853907" y="-75365"/>
                    <a:pt x="640547" y="262565"/>
                  </a:cubicBezTo>
                  <a:cubicBezTo>
                    <a:pt x="427187" y="600495"/>
                    <a:pt x="-110851" y="1817045"/>
                    <a:pt x="20345" y="2115219"/>
                  </a:cubicBezTo>
                  <a:cubicBezTo>
                    <a:pt x="151541" y="2413393"/>
                    <a:pt x="1011608" y="2140399"/>
                    <a:pt x="1419775" y="2043658"/>
                  </a:cubicBezTo>
                  <a:close/>
                </a:path>
              </a:pathLst>
            </a:custGeom>
            <a:solidFill>
              <a:schemeClr val="accent1">
                <a:lumMod val="40000"/>
                <a:lumOff val="60000"/>
                <a:alpha val="3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55" name="文本框 54"/>
            <p:cNvSpPr txBox="1"/>
            <p:nvPr/>
          </p:nvSpPr>
          <p:spPr>
            <a:xfrm rot="1236979">
              <a:off x="5035611" y="5081382"/>
              <a:ext cx="187583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Loxodont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africana</a:t>
              </a:r>
              <a:r>
                <a:rPr lang="en-US" altLang="zh-CN" sz="800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800" dirty="0">
                  <a:latin typeface="Arial" panose="020B0604020202020204" pitchFamily="34" charset="0"/>
                  <a:cs typeface="Arial" panose="020B0604020202020204" pitchFamily="34" charset="0"/>
                </a:rPr>
                <a:t>(XP_003412410)</a:t>
              </a:r>
              <a:endParaRPr lang="en-US" altLang="zh-CN" sz="800" dirty="0" smtClean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7" name="任意多边形 286"/>
            <p:cNvSpPr/>
            <p:nvPr/>
          </p:nvSpPr>
          <p:spPr>
            <a:xfrm>
              <a:off x="4870906" y="3644651"/>
              <a:ext cx="2043052" cy="2998890"/>
            </a:xfrm>
            <a:custGeom>
              <a:avLst/>
              <a:gdLst>
                <a:gd name="connsiteX0" fmla="*/ 125083 w 2043052"/>
                <a:gd name="connsiteY0" fmla="*/ 818711 h 2998890"/>
                <a:gd name="connsiteX1" fmla="*/ 1468853 w 2043052"/>
                <a:gd name="connsiteY1" fmla="*/ 7678 h 2998890"/>
                <a:gd name="connsiteX2" fmla="*/ 2041347 w 2043052"/>
                <a:gd name="connsiteY2" fmla="*/ 1319643 h 2998890"/>
                <a:gd name="connsiteX3" fmla="*/ 1627879 w 2043052"/>
                <a:gd name="connsiteY3" fmla="*/ 2766781 h 2998890"/>
                <a:gd name="connsiteX4" fmla="*/ 1134898 w 2043052"/>
                <a:gd name="connsiteY4" fmla="*/ 2886050 h 2998890"/>
                <a:gd name="connsiteX5" fmla="*/ 172790 w 2043052"/>
                <a:gd name="connsiteY5" fmla="*/ 1661550 h 2998890"/>
                <a:gd name="connsiteX6" fmla="*/ 125083 w 2043052"/>
                <a:gd name="connsiteY6" fmla="*/ 818711 h 29988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2043052" h="2998890">
                  <a:moveTo>
                    <a:pt x="125083" y="818711"/>
                  </a:moveTo>
                  <a:cubicBezTo>
                    <a:pt x="341093" y="543066"/>
                    <a:pt x="1149476" y="-75811"/>
                    <a:pt x="1468853" y="7678"/>
                  </a:cubicBezTo>
                  <a:cubicBezTo>
                    <a:pt x="1788230" y="91167"/>
                    <a:pt x="2014843" y="859793"/>
                    <a:pt x="2041347" y="1319643"/>
                  </a:cubicBezTo>
                  <a:cubicBezTo>
                    <a:pt x="2067851" y="1779493"/>
                    <a:pt x="1778954" y="2505713"/>
                    <a:pt x="1627879" y="2766781"/>
                  </a:cubicBezTo>
                  <a:cubicBezTo>
                    <a:pt x="1476804" y="3027849"/>
                    <a:pt x="1377413" y="3070255"/>
                    <a:pt x="1134898" y="2886050"/>
                  </a:cubicBezTo>
                  <a:cubicBezTo>
                    <a:pt x="892383" y="2701845"/>
                    <a:pt x="341093" y="2010082"/>
                    <a:pt x="172790" y="1661550"/>
                  </a:cubicBezTo>
                  <a:cubicBezTo>
                    <a:pt x="4487" y="1313018"/>
                    <a:pt x="-90927" y="1094356"/>
                    <a:pt x="125083" y="818711"/>
                  </a:cubicBezTo>
                  <a:close/>
                </a:path>
              </a:pathLst>
            </a:custGeom>
            <a:solidFill>
              <a:schemeClr val="accent6">
                <a:lumMod val="20000"/>
                <a:lumOff val="80000"/>
                <a:alpha val="3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86" name="任意多边形 285"/>
            <p:cNvSpPr/>
            <p:nvPr/>
          </p:nvSpPr>
          <p:spPr>
            <a:xfrm>
              <a:off x="2787748" y="1024299"/>
              <a:ext cx="3520029" cy="2924058"/>
            </a:xfrm>
            <a:custGeom>
              <a:avLst/>
              <a:gdLst>
                <a:gd name="connsiteX0" fmla="*/ 2025134 w 3520029"/>
                <a:gd name="connsiteY0" fmla="*/ 132627 h 2924058"/>
                <a:gd name="connsiteX1" fmla="*/ 61162 w 3520029"/>
                <a:gd name="connsiteY1" fmla="*/ 196238 h 2924058"/>
                <a:gd name="connsiteX2" fmla="*/ 649558 w 3520029"/>
                <a:gd name="connsiteY2" fmla="*/ 2366944 h 2924058"/>
                <a:gd name="connsiteX3" fmla="*/ 2184160 w 3520029"/>
                <a:gd name="connsiteY3" fmla="*/ 2923535 h 2924058"/>
                <a:gd name="connsiteX4" fmla="*/ 3496125 w 3520029"/>
                <a:gd name="connsiteY4" fmla="*/ 2311285 h 2924058"/>
                <a:gd name="connsiteX5" fmla="*/ 2955437 w 3520029"/>
                <a:gd name="connsiteY5" fmla="*/ 466582 h 2924058"/>
                <a:gd name="connsiteX6" fmla="*/ 2025134 w 3520029"/>
                <a:gd name="connsiteY6" fmla="*/ 132627 h 292405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</a:cxnLst>
              <a:rect l="l" t="t" r="r" b="b"/>
              <a:pathLst>
                <a:path w="3520029" h="2924058">
                  <a:moveTo>
                    <a:pt x="2025134" y="132627"/>
                  </a:moveTo>
                  <a:cubicBezTo>
                    <a:pt x="1542755" y="87570"/>
                    <a:pt x="290425" y="-176148"/>
                    <a:pt x="61162" y="196238"/>
                  </a:cubicBezTo>
                  <a:cubicBezTo>
                    <a:pt x="-168101" y="568624"/>
                    <a:pt x="295725" y="1912395"/>
                    <a:pt x="649558" y="2366944"/>
                  </a:cubicBezTo>
                  <a:cubicBezTo>
                    <a:pt x="1003391" y="2821493"/>
                    <a:pt x="1709732" y="2932811"/>
                    <a:pt x="2184160" y="2923535"/>
                  </a:cubicBezTo>
                  <a:cubicBezTo>
                    <a:pt x="2658588" y="2914259"/>
                    <a:pt x="3367579" y="2720777"/>
                    <a:pt x="3496125" y="2311285"/>
                  </a:cubicBezTo>
                  <a:cubicBezTo>
                    <a:pt x="3624671" y="1901793"/>
                    <a:pt x="3204578" y="831017"/>
                    <a:pt x="2955437" y="466582"/>
                  </a:cubicBezTo>
                  <a:cubicBezTo>
                    <a:pt x="2706296" y="102147"/>
                    <a:pt x="2507513" y="177684"/>
                    <a:pt x="2025134" y="132627"/>
                  </a:cubicBezTo>
                  <a:close/>
                </a:path>
              </a:pathLst>
            </a:custGeom>
            <a:solidFill>
              <a:schemeClr val="accent4">
                <a:lumMod val="20000"/>
                <a:lumOff val="80000"/>
                <a:alpha val="22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652</TotalTime>
  <Words>201</Words>
  <Application>Microsoft Office PowerPoint</Application>
  <PresentationFormat>自定义</PresentationFormat>
  <Paragraphs>4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